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1176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2009990686648"/>
          <c:y val="8.2840572347811378E-2"/>
          <c:w val="0.8323079615048119"/>
          <c:h val="0.6600007225565161"/>
        </c:manualLayout>
      </c:layout>
      <c:scatterChart>
        <c:scatterStyle val="smoothMarker"/>
        <c:varyColors val="0"/>
        <c:ser>
          <c:idx val="1"/>
          <c:order val="0"/>
          <c:tx>
            <c:strRef>
              <c:f>'D:\pH.D\[กว่าจะเป็น phD.xlsx]DPPH invitro'!$D$40</c:f>
              <c:strCache>
                <c:ptCount val="1"/>
                <c:pt idx="0">
                  <c:v>Flavourzym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FRAP Invitro'!$O$41:$O$47</c:f>
                <c:numCache>
                  <c:formatCode>General</c:formatCode>
                  <c:ptCount val="7"/>
                  <c:pt idx="0">
                    <c:v>1.2719288144530791</c:v>
                  </c:pt>
                  <c:pt idx="1">
                    <c:v>0.16769863417617784</c:v>
                  </c:pt>
                  <c:pt idx="2">
                    <c:v>0.37891220304709938</c:v>
                  </c:pt>
                  <c:pt idx="3">
                    <c:v>0.78563487247747676</c:v>
                  </c:pt>
                  <c:pt idx="4">
                    <c:v>0.40715684119531398</c:v>
                  </c:pt>
                  <c:pt idx="5">
                    <c:v>0.46645676112412104</c:v>
                  </c:pt>
                  <c:pt idx="6">
                    <c:v>0.90961712693479513</c:v>
                  </c:pt>
                </c:numCache>
              </c:numRef>
            </c:plus>
            <c:minus>
              <c:numRef>
                <c:f>'D:\pH.D\[กว่าจะเป็น phD.xlsx]FRAP Invitro'!$O$41:$O$47</c:f>
                <c:numCache>
                  <c:formatCode>General</c:formatCode>
                  <c:ptCount val="7"/>
                  <c:pt idx="0">
                    <c:v>1.2719288144530791</c:v>
                  </c:pt>
                  <c:pt idx="1">
                    <c:v>0.16769863417617784</c:v>
                  </c:pt>
                  <c:pt idx="2">
                    <c:v>0.37891220304709938</c:v>
                  </c:pt>
                  <c:pt idx="3">
                    <c:v>0.78563487247747676</c:v>
                  </c:pt>
                  <c:pt idx="4">
                    <c:v>0.40715684119531398</c:v>
                  </c:pt>
                  <c:pt idx="5">
                    <c:v>0.46645676112412104</c:v>
                  </c:pt>
                  <c:pt idx="6">
                    <c:v>0.90961712693479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DPPH invitro'!$B$41:$B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DPPH invitro'!$D$41:$D$47</c:f>
              <c:numCache>
                <c:formatCode>General</c:formatCode>
                <c:ptCount val="7"/>
                <c:pt idx="0">
                  <c:v>176.18620414673046</c:v>
                </c:pt>
                <c:pt idx="1">
                  <c:v>450.55821371610841</c:v>
                </c:pt>
                <c:pt idx="2">
                  <c:v>391.0563121089437</c:v>
                </c:pt>
                <c:pt idx="3">
                  <c:v>118.0581114791641</c:v>
                </c:pt>
                <c:pt idx="4">
                  <c:v>117.80251911830857</c:v>
                </c:pt>
                <c:pt idx="5">
                  <c:v>128.79299063509589</c:v>
                </c:pt>
                <c:pt idx="6">
                  <c:v>119.0804809225861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AA4B-44B9-A796-8E053FD2BBBD}"/>
            </c:ext>
          </c:extLst>
        </c:ser>
        <c:ser>
          <c:idx val="2"/>
          <c:order val="1"/>
          <c:tx>
            <c:strRef>
              <c:f>'D:\pH.D\[กว่าจะเป็น phD.xlsx]DPPH invitro'!$E$40</c:f>
              <c:strCache>
                <c:ptCount val="1"/>
                <c:pt idx="0">
                  <c:v>Alcalas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DPPH invitro'!$O$41:$O$47</c:f>
                <c:numCache>
                  <c:formatCode>General</c:formatCode>
                  <c:ptCount val="7"/>
                  <c:pt idx="0">
                    <c:v>0.90428779548187754</c:v>
                  </c:pt>
                  <c:pt idx="1">
                    <c:v>0.71245654238567746</c:v>
                  </c:pt>
                  <c:pt idx="2">
                    <c:v>2.3563065153551608</c:v>
                  </c:pt>
                  <c:pt idx="3">
                    <c:v>7.2784608966812616</c:v>
                  </c:pt>
                  <c:pt idx="4">
                    <c:v>0.58563567033643082</c:v>
                  </c:pt>
                  <c:pt idx="5">
                    <c:v>2.2542898480065721</c:v>
                  </c:pt>
                  <c:pt idx="6">
                    <c:v>1.3745071831420244</c:v>
                  </c:pt>
                </c:numCache>
              </c:numRef>
            </c:plus>
            <c:minus>
              <c:numRef>
                <c:f>'D:\pH.D\[กว่าจะเป็น phD.xlsx]DPPH invitro'!$O$41:$O$47</c:f>
                <c:numCache>
                  <c:formatCode>General</c:formatCode>
                  <c:ptCount val="7"/>
                  <c:pt idx="0">
                    <c:v>0.90428779548187754</c:v>
                  </c:pt>
                  <c:pt idx="1">
                    <c:v>0.71245654238567746</c:v>
                  </c:pt>
                  <c:pt idx="2">
                    <c:v>2.3563065153551608</c:v>
                  </c:pt>
                  <c:pt idx="3">
                    <c:v>7.2784608966812616</c:v>
                  </c:pt>
                  <c:pt idx="4">
                    <c:v>0.58563567033643082</c:v>
                  </c:pt>
                  <c:pt idx="5">
                    <c:v>2.2542898480065721</c:v>
                  </c:pt>
                  <c:pt idx="6">
                    <c:v>1.37450718314202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DPPH invitro'!$B$41:$B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DPPH invitro'!$E$41:$E$47</c:f>
              <c:numCache>
                <c:formatCode>General</c:formatCode>
                <c:ptCount val="7"/>
                <c:pt idx="0">
                  <c:v>162.53118226802437</c:v>
                </c:pt>
                <c:pt idx="1">
                  <c:v>349.85482353903404</c:v>
                </c:pt>
                <c:pt idx="2">
                  <c:v>140.2690876375087</c:v>
                </c:pt>
                <c:pt idx="3">
                  <c:v>144.97198707725019</c:v>
                </c:pt>
                <c:pt idx="4">
                  <c:v>153.63656811025228</c:v>
                </c:pt>
                <c:pt idx="5">
                  <c:v>149.34261644787958</c:v>
                </c:pt>
                <c:pt idx="6">
                  <c:v>137.45102850366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AA4B-44B9-A796-8E053FD2BBBD}"/>
            </c:ext>
          </c:extLst>
        </c:ser>
        <c:ser>
          <c:idx val="3"/>
          <c:order val="2"/>
          <c:tx>
            <c:strRef>
              <c:f>'D:\pH.D\[กว่าจะเป็น phD.xlsx]DPPH invitro'!$F$40</c:f>
              <c:strCache>
                <c:ptCount val="1"/>
                <c:pt idx="0">
                  <c:v>Papain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DPPH invitro'!$P$41:$P$47</c:f>
                <c:numCache>
                  <c:formatCode>General</c:formatCode>
                  <c:ptCount val="7"/>
                  <c:pt idx="0">
                    <c:v>0.52052436956651826</c:v>
                  </c:pt>
                  <c:pt idx="1">
                    <c:v>3.4507808513756202</c:v>
                  </c:pt>
                  <c:pt idx="2">
                    <c:v>0.89530322905864856</c:v>
                  </c:pt>
                  <c:pt idx="3">
                    <c:v>3.3141302430314119</c:v>
                  </c:pt>
                  <c:pt idx="4">
                    <c:v>10.882923435794561</c:v>
                  </c:pt>
                  <c:pt idx="5">
                    <c:v>2.032079827659286</c:v>
                  </c:pt>
                  <c:pt idx="6">
                    <c:v>1.764142837968468</c:v>
                  </c:pt>
                </c:numCache>
              </c:numRef>
            </c:plus>
            <c:minus>
              <c:numRef>
                <c:f>'D:\pH.D\[กว่าจะเป็น phD.xlsx]FRAP Invitro'!$P$41:$P$47</c:f>
                <c:numCache>
                  <c:formatCode>General</c:formatCode>
                  <c:ptCount val="7"/>
                  <c:pt idx="0">
                    <c:v>0.50014516797208797</c:v>
                  </c:pt>
                  <c:pt idx="1">
                    <c:v>0.83318059466620942</c:v>
                  </c:pt>
                  <c:pt idx="2">
                    <c:v>0.50309590252858627</c:v>
                  </c:pt>
                  <c:pt idx="3">
                    <c:v>0.60464602434756576</c:v>
                  </c:pt>
                  <c:pt idx="4">
                    <c:v>0.2402619671457174</c:v>
                  </c:pt>
                  <c:pt idx="5">
                    <c:v>0.65629518728546987</c:v>
                  </c:pt>
                  <c:pt idx="6">
                    <c:v>0.768491685053132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DPPH invitro'!$B$41:$B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DPPH invitro'!$F$41:$F$47</c:f>
              <c:numCache>
                <c:formatCode>General</c:formatCode>
                <c:ptCount val="7"/>
                <c:pt idx="0">
                  <c:v>272.83206559522347</c:v>
                </c:pt>
                <c:pt idx="1">
                  <c:v>281.27939312149846</c:v>
                </c:pt>
                <c:pt idx="2">
                  <c:v>291.3241729031202</c:v>
                </c:pt>
                <c:pt idx="3">
                  <c:v>111.18012104854206</c:v>
                </c:pt>
                <c:pt idx="4">
                  <c:v>99.62990226148122</c:v>
                </c:pt>
                <c:pt idx="5">
                  <c:v>111.66830245777611</c:v>
                </c:pt>
                <c:pt idx="6">
                  <c:v>101.4190487874698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AA4B-44B9-A796-8E053FD2BBBD}"/>
            </c:ext>
          </c:extLst>
        </c:ser>
        <c:ser>
          <c:idx val="4"/>
          <c:order val="3"/>
          <c:tx>
            <c:strRef>
              <c:f>'D:\pH.D\[กว่าจะเป็น phD.xlsx]DPPH invitro'!$G$40</c:f>
              <c:strCache>
                <c:ptCount val="1"/>
                <c:pt idx="0">
                  <c:v>Fresh PP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DPPH invitro'!$M$41:$M$47</c:f>
                <c:numCache>
                  <c:formatCode>General</c:formatCode>
                  <c:ptCount val="7"/>
                  <c:pt idx="0">
                    <c:v>2.2056506384299439</c:v>
                  </c:pt>
                  <c:pt idx="1">
                    <c:v>0.82702989854841591</c:v>
                  </c:pt>
                  <c:pt idx="2">
                    <c:v>4.8357642380412882</c:v>
                  </c:pt>
                  <c:pt idx="3">
                    <c:v>0.73679790339629414</c:v>
                  </c:pt>
                  <c:pt idx="4">
                    <c:v>0.81988993847097802</c:v>
                  </c:pt>
                  <c:pt idx="5">
                    <c:v>2.2254155472784833</c:v>
                  </c:pt>
                  <c:pt idx="6">
                    <c:v>5.56604816947457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DPPH invitro'!$B$41:$B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DPPH invitro'!$G$41:$G$47</c:f>
              <c:numCache>
                <c:formatCode>General</c:formatCode>
                <c:ptCount val="7"/>
                <c:pt idx="0">
                  <c:v>49.993865783339459</c:v>
                </c:pt>
                <c:pt idx="1">
                  <c:v>58.920428986218461</c:v>
                </c:pt>
                <c:pt idx="2">
                  <c:v>35.648744530323476</c:v>
                </c:pt>
                <c:pt idx="3">
                  <c:v>32.818059133848607</c:v>
                </c:pt>
                <c:pt idx="4">
                  <c:v>34.913916492863855</c:v>
                </c:pt>
                <c:pt idx="5">
                  <c:v>35.290915225125751</c:v>
                </c:pt>
                <c:pt idx="6">
                  <c:v>30.7860998650472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AA4B-44B9-A796-8E053FD2BB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7585912"/>
        <c:axId val="417589832"/>
      </c:scatterChart>
      <c:valAx>
        <c:axId val="417585912"/>
        <c:scaling>
          <c:orientation val="minMax"/>
          <c:max val="36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gestion time 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9832"/>
        <c:crosses val="autoZero"/>
        <c:crossBetween val="midCat"/>
        <c:majorUnit val="30"/>
      </c:valAx>
      <c:valAx>
        <c:axId val="417589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b="0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</a:t>
                </a:r>
                <a:r>
                  <a:rPr lang="en-US" sz="1050" b="0" i="0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</a:t>
                </a:r>
                <a:r>
                  <a:rPr lang="en-US" sz="1050" b="0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cavenging activity  (mmol TE/g)</a:t>
                </a:r>
                <a:endParaRPr lang="en-GB" sz="1050" b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0161713656760647E-2"/>
              <c:y val="5.459103326369917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59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95037362895696"/>
          <c:y val="0.15348944741135973"/>
          <c:w val="0.83986761367222951"/>
          <c:h val="0.620373054633993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D:\pH.D\[กว่าจะเป็น phD.xlsx]ABTS INvitro'!$E$45</c:f>
              <c:strCache>
                <c:ptCount val="1"/>
                <c:pt idx="0">
                  <c:v>Fresh PP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ABTS INvitro'!$O$46:$O$52</c:f>
                <c:numCache>
                  <c:formatCode>General</c:formatCode>
                  <c:ptCount val="7"/>
                  <c:pt idx="0">
                    <c:v>1.4080405918637018</c:v>
                  </c:pt>
                  <c:pt idx="1">
                    <c:v>5.4347940183446219</c:v>
                  </c:pt>
                  <c:pt idx="2">
                    <c:v>0.52477477625415991</c:v>
                  </c:pt>
                  <c:pt idx="3">
                    <c:v>2.2259629519596693</c:v>
                  </c:pt>
                  <c:pt idx="4">
                    <c:v>2.3483726123573523</c:v>
                  </c:pt>
                  <c:pt idx="5">
                    <c:v>7.826477471850624</c:v>
                  </c:pt>
                  <c:pt idx="6">
                    <c:v>9.0601668756097897</c:v>
                  </c:pt>
                </c:numCache>
              </c:numRef>
            </c:plus>
            <c:minus>
              <c:numRef>
                <c:f>'D:\pH.D\[กว่าจะเป็น phD.xlsx]ABTS INvitro'!$O$46:$O$52</c:f>
                <c:numCache>
                  <c:formatCode>General</c:formatCode>
                  <c:ptCount val="7"/>
                  <c:pt idx="0">
                    <c:v>1.4080405918637018</c:v>
                  </c:pt>
                  <c:pt idx="1">
                    <c:v>5.4347940183446219</c:v>
                  </c:pt>
                  <c:pt idx="2">
                    <c:v>0.52477477625415991</c:v>
                  </c:pt>
                  <c:pt idx="3">
                    <c:v>2.2259629519596693</c:v>
                  </c:pt>
                  <c:pt idx="4">
                    <c:v>2.3483726123573523</c:v>
                  </c:pt>
                  <c:pt idx="5">
                    <c:v>7.826477471850624</c:v>
                  </c:pt>
                  <c:pt idx="6">
                    <c:v>9.06016687560978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ABTS INvitro'!$D$46:$D$52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ABTS INvitro'!$E$46:$E$52</c:f>
              <c:numCache>
                <c:formatCode>General</c:formatCode>
                <c:ptCount val="7"/>
                <c:pt idx="0">
                  <c:v>22.191919191919187</c:v>
                </c:pt>
                <c:pt idx="1">
                  <c:v>116.98484848484846</c:v>
                </c:pt>
                <c:pt idx="2">
                  <c:v>119.48316498316495</c:v>
                </c:pt>
                <c:pt idx="3">
                  <c:v>124.78619528619527</c:v>
                </c:pt>
                <c:pt idx="4">
                  <c:v>140.82491582491579</c:v>
                </c:pt>
                <c:pt idx="5">
                  <c:v>193.17171717171712</c:v>
                </c:pt>
                <c:pt idx="6">
                  <c:v>209.2929292929292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91D-47AD-94E1-D87C5E099433}"/>
            </c:ext>
          </c:extLst>
        </c:ser>
        <c:ser>
          <c:idx val="1"/>
          <c:order val="1"/>
          <c:tx>
            <c:strRef>
              <c:f>'D:\pH.D\[กว่าจะเป็น phD.xlsx]ABTS INvitro'!$F$45</c:f>
              <c:strCache>
                <c:ptCount val="1"/>
                <c:pt idx="0">
                  <c:v>Alcalas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ABTS INvitro'!$P$46:$P$52</c:f>
                <c:numCache>
                  <c:formatCode>General</c:formatCode>
                  <c:ptCount val="7"/>
                  <c:pt idx="0">
                    <c:v>36.069847630737193</c:v>
                  </c:pt>
                  <c:pt idx="1">
                    <c:v>27.497081930186248</c:v>
                  </c:pt>
                  <c:pt idx="2">
                    <c:v>35.417114547303974</c:v>
                  </c:pt>
                  <c:pt idx="3">
                    <c:v>5.7876231720311129</c:v>
                  </c:pt>
                  <c:pt idx="4">
                    <c:v>89.838439109615834</c:v>
                  </c:pt>
                  <c:pt idx="5">
                    <c:v>49.59105628349996</c:v>
                  </c:pt>
                  <c:pt idx="6">
                    <c:v>21.87515942192757</c:v>
                  </c:pt>
                </c:numCache>
              </c:numRef>
            </c:plus>
            <c:minus>
              <c:numRef>
                <c:f>'D:\pH.D\[กว่าจะเป็น phD.xlsx]ABTS INvitro'!$P$46:$P$52</c:f>
                <c:numCache>
                  <c:formatCode>General</c:formatCode>
                  <c:ptCount val="7"/>
                  <c:pt idx="0">
                    <c:v>36.069847630737193</c:v>
                  </c:pt>
                  <c:pt idx="1">
                    <c:v>27.497081930186248</c:v>
                  </c:pt>
                  <c:pt idx="2">
                    <c:v>35.417114547303974</c:v>
                  </c:pt>
                  <c:pt idx="3">
                    <c:v>5.7876231720311129</c:v>
                  </c:pt>
                  <c:pt idx="4">
                    <c:v>89.838439109615834</c:v>
                  </c:pt>
                  <c:pt idx="5">
                    <c:v>49.59105628349996</c:v>
                  </c:pt>
                  <c:pt idx="6">
                    <c:v>21.875159421927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ABTS INvitro'!$D$46:$D$52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ABTS INvitro'!$F$46:$F$52</c:f>
              <c:numCache>
                <c:formatCode>General</c:formatCode>
                <c:ptCount val="7"/>
                <c:pt idx="0">
                  <c:v>3162.962962962963</c:v>
                </c:pt>
                <c:pt idx="1">
                  <c:v>3220.2356902356901</c:v>
                </c:pt>
                <c:pt idx="2">
                  <c:v>3221.4141414141413</c:v>
                </c:pt>
                <c:pt idx="3">
                  <c:v>3273.0303030303025</c:v>
                </c:pt>
                <c:pt idx="4">
                  <c:v>3688.2154882154878</c:v>
                </c:pt>
                <c:pt idx="5">
                  <c:v>4455.2188552188545</c:v>
                </c:pt>
                <c:pt idx="6">
                  <c:v>4569.696969696969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291D-47AD-94E1-D87C5E099433}"/>
            </c:ext>
          </c:extLst>
        </c:ser>
        <c:ser>
          <c:idx val="2"/>
          <c:order val="2"/>
          <c:tx>
            <c:strRef>
              <c:f>'D:\pH.D\[กว่าจะเป็น phD.xlsx]ABTS INvitro'!$G$45</c:f>
              <c:strCache>
                <c:ptCount val="1"/>
                <c:pt idx="0">
                  <c:v>Flavourzym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ABTS INvitro'!$Q$46:$Q$52</c:f>
                <c:numCache>
                  <c:formatCode>General</c:formatCode>
                  <c:ptCount val="7"/>
                  <c:pt idx="0">
                    <c:v>131.1926409128605</c:v>
                  </c:pt>
                  <c:pt idx="1">
                    <c:v>22.222222222222172</c:v>
                  </c:pt>
                  <c:pt idx="2">
                    <c:v>51.257028106526192</c:v>
                  </c:pt>
                  <c:pt idx="3">
                    <c:v>111.75814057522398</c:v>
                  </c:pt>
                  <c:pt idx="4">
                    <c:v>20.411373153169102</c:v>
                  </c:pt>
                  <c:pt idx="5">
                    <c:v>143.76478274320814</c:v>
                  </c:pt>
                  <c:pt idx="6">
                    <c:v>21.875159421927044</c:v>
                  </c:pt>
                </c:numCache>
              </c:numRef>
            </c:plus>
            <c:minus>
              <c:numRef>
                <c:f>'D:\pH.D\[กว่าจะเป็น phD.xlsx]ABTS INvitro'!$Q$46:$Q$52</c:f>
                <c:numCache>
                  <c:formatCode>General</c:formatCode>
                  <c:ptCount val="7"/>
                  <c:pt idx="0">
                    <c:v>131.1926409128605</c:v>
                  </c:pt>
                  <c:pt idx="1">
                    <c:v>22.222222222222172</c:v>
                  </c:pt>
                  <c:pt idx="2">
                    <c:v>51.257028106526192</c:v>
                  </c:pt>
                  <c:pt idx="3">
                    <c:v>111.75814057522398</c:v>
                  </c:pt>
                  <c:pt idx="4">
                    <c:v>20.411373153169102</c:v>
                  </c:pt>
                  <c:pt idx="5">
                    <c:v>143.76478274320814</c:v>
                  </c:pt>
                  <c:pt idx="6">
                    <c:v>21.87515942192704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ABTS INvitro'!$D$46:$D$52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ABTS INvitro'!$G$46:$G$52</c:f>
              <c:numCache>
                <c:formatCode>General</c:formatCode>
                <c:ptCount val="7"/>
                <c:pt idx="0">
                  <c:v>4565.6565656565645</c:v>
                </c:pt>
                <c:pt idx="1">
                  <c:v>4452.5252525252527</c:v>
                </c:pt>
                <c:pt idx="2">
                  <c:v>4505.0505050505044</c:v>
                </c:pt>
                <c:pt idx="3">
                  <c:v>4516.8350168350162</c:v>
                </c:pt>
                <c:pt idx="4">
                  <c:v>4673.4006734006734</c:v>
                </c:pt>
                <c:pt idx="5">
                  <c:v>5282.9629629629617</c:v>
                </c:pt>
                <c:pt idx="6">
                  <c:v>5579.797979797978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291D-47AD-94E1-D87C5E099433}"/>
            </c:ext>
          </c:extLst>
        </c:ser>
        <c:ser>
          <c:idx val="3"/>
          <c:order val="3"/>
          <c:tx>
            <c:strRef>
              <c:f>'D:\pH.D\[กว่าจะเป็น phD.xlsx]ABTS INvitro'!$H$45</c:f>
              <c:strCache>
                <c:ptCount val="1"/>
                <c:pt idx="0">
                  <c:v>Papain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ABTS INvitro'!$R$46:$R$52</c:f>
                <c:numCache>
                  <c:formatCode>General</c:formatCode>
                  <c:ptCount val="7"/>
                  <c:pt idx="0">
                    <c:v>8.7811034681230993</c:v>
                  </c:pt>
                  <c:pt idx="1">
                    <c:v>2.6364410376036349</c:v>
                  </c:pt>
                  <c:pt idx="2">
                    <c:v>6.8458324472430654</c:v>
                  </c:pt>
                  <c:pt idx="3">
                    <c:v>19.209277990480494</c:v>
                  </c:pt>
                  <c:pt idx="4">
                    <c:v>12.866039772357038</c:v>
                  </c:pt>
                  <c:pt idx="5">
                    <c:v>98.59356858409285</c:v>
                  </c:pt>
                  <c:pt idx="6">
                    <c:v>30.325468684707676</c:v>
                  </c:pt>
                </c:numCache>
              </c:numRef>
            </c:plus>
            <c:minus>
              <c:numRef>
                <c:f>'D:\pH.D\[กว่าจะเป็น phD.xlsx]ABTS INvitro'!$R$46:$R$52</c:f>
                <c:numCache>
                  <c:formatCode>General</c:formatCode>
                  <c:ptCount val="7"/>
                  <c:pt idx="0">
                    <c:v>8.7811034681230993</c:v>
                  </c:pt>
                  <c:pt idx="1">
                    <c:v>2.6364410376036349</c:v>
                  </c:pt>
                  <c:pt idx="2">
                    <c:v>6.8458324472430654</c:v>
                  </c:pt>
                  <c:pt idx="3">
                    <c:v>19.209277990480494</c:v>
                  </c:pt>
                  <c:pt idx="4">
                    <c:v>12.866039772357038</c:v>
                  </c:pt>
                  <c:pt idx="5">
                    <c:v>98.59356858409285</c:v>
                  </c:pt>
                  <c:pt idx="6">
                    <c:v>30.3254686847076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ABTS INvitro'!$D$46:$D$52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ABTS INvitro'!$H$46:$H$52</c:f>
              <c:numCache>
                <c:formatCode>General</c:formatCode>
                <c:ptCount val="7"/>
                <c:pt idx="0">
                  <c:v>334.81481481481467</c:v>
                </c:pt>
                <c:pt idx="1">
                  <c:v>357.57575757575751</c:v>
                </c:pt>
                <c:pt idx="2">
                  <c:v>334.70707070707067</c:v>
                </c:pt>
                <c:pt idx="3">
                  <c:v>363.77104377104359</c:v>
                </c:pt>
                <c:pt idx="4">
                  <c:v>399.07407407407385</c:v>
                </c:pt>
                <c:pt idx="5">
                  <c:v>479.29292929292927</c:v>
                </c:pt>
                <c:pt idx="6">
                  <c:v>565.9932659932652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291D-47AD-94E1-D87C5E0994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7582776"/>
        <c:axId val="417586696"/>
      </c:scatterChart>
      <c:valAx>
        <c:axId val="417582776"/>
        <c:scaling>
          <c:orientation val="minMax"/>
          <c:max val="36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gestion time 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6696"/>
        <c:crosses val="autoZero"/>
        <c:crossBetween val="midCat"/>
        <c:majorUnit val="30"/>
      </c:valAx>
      <c:valAx>
        <c:axId val="417586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b="0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BTS</a:t>
                </a:r>
                <a:r>
                  <a:rPr lang="en-US" sz="1050" b="0" i="0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+</a:t>
                </a:r>
                <a:r>
                  <a:rPr lang="en-US" sz="1050" b="0" i="0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b="0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avenging activity (mmol TE/g)</a:t>
                </a:r>
                <a:endParaRPr lang="en-GB" sz="1050" b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2097372283921437E-2"/>
              <c:y val="6.639109296123123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27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03133868421185"/>
          <c:y val="0.13748953605387185"/>
          <c:w val="0.83608664971037228"/>
          <c:h val="0.6109135420569733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D:\pH.D\[กว่าจะเป็น phD.xlsx]FRAP Invitro'!$B$40</c:f>
              <c:strCache>
                <c:ptCount val="1"/>
                <c:pt idx="0">
                  <c:v>Fresh PP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FRAP Invitro'!$M$41:$M$47</c:f>
                <c:numCache>
                  <c:formatCode>General</c:formatCode>
                  <c:ptCount val="7"/>
                  <c:pt idx="0">
                    <c:v>0.86627684208773292</c:v>
                  </c:pt>
                  <c:pt idx="1">
                    <c:v>0.34855506570368616</c:v>
                  </c:pt>
                  <c:pt idx="2">
                    <c:v>1.3536926264485467</c:v>
                  </c:pt>
                  <c:pt idx="3">
                    <c:v>1.6143689903696199</c:v>
                  </c:pt>
                  <c:pt idx="4">
                    <c:v>2.1270779023739719</c:v>
                  </c:pt>
                  <c:pt idx="5">
                    <c:v>3.2654149097793663</c:v>
                  </c:pt>
                  <c:pt idx="6">
                    <c:v>3.0551591631377586</c:v>
                  </c:pt>
                </c:numCache>
              </c:numRef>
            </c:plus>
            <c:minus>
              <c:numRef>
                <c:f>'D:\pH.D\[กว่าจะเป็น phD.xlsx]FRAP Invitro'!$M$41:$M$47</c:f>
                <c:numCache>
                  <c:formatCode>General</c:formatCode>
                  <c:ptCount val="7"/>
                  <c:pt idx="0">
                    <c:v>0.86627684208773292</c:v>
                  </c:pt>
                  <c:pt idx="1">
                    <c:v>0.34855506570368616</c:v>
                  </c:pt>
                  <c:pt idx="2">
                    <c:v>1.3536926264485467</c:v>
                  </c:pt>
                  <c:pt idx="3">
                    <c:v>1.6143689903696199</c:v>
                  </c:pt>
                  <c:pt idx="4">
                    <c:v>2.1270779023739719</c:v>
                  </c:pt>
                  <c:pt idx="5">
                    <c:v>3.2654149097793663</c:v>
                  </c:pt>
                  <c:pt idx="6">
                    <c:v>3.05515916313775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FRAP Invitro'!$A$41:$A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FRAP Invitro'!$B$41:$B$47</c:f>
              <c:numCache>
                <c:formatCode>General</c:formatCode>
                <c:ptCount val="7"/>
                <c:pt idx="0">
                  <c:v>8.9293151415196519</c:v>
                </c:pt>
                <c:pt idx="1">
                  <c:v>93.038132840221877</c:v>
                </c:pt>
                <c:pt idx="2">
                  <c:v>100.08829360121278</c:v>
                </c:pt>
                <c:pt idx="3">
                  <c:v>81.230113115764581</c:v>
                </c:pt>
                <c:pt idx="4">
                  <c:v>81.589951188631787</c:v>
                </c:pt>
                <c:pt idx="5">
                  <c:v>73.660186249521061</c:v>
                </c:pt>
                <c:pt idx="6">
                  <c:v>73.12709280823628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849D-4E06-AE06-F1FF729B198F}"/>
            </c:ext>
          </c:extLst>
        </c:ser>
        <c:ser>
          <c:idx val="1"/>
          <c:order val="1"/>
          <c:tx>
            <c:strRef>
              <c:f>'D:\pH.D\[กว่าจะเป็น phD.xlsx]FRAP Invitro'!$C$40</c:f>
              <c:strCache>
                <c:ptCount val="1"/>
                <c:pt idx="0">
                  <c:v>Alcalas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FRAP Invitro'!$N$41:$N$47</c:f>
                <c:numCache>
                  <c:formatCode>General</c:formatCode>
                  <c:ptCount val="7"/>
                  <c:pt idx="0">
                    <c:v>1.2719288144530927</c:v>
                  </c:pt>
                  <c:pt idx="1">
                    <c:v>0.19991004048172556</c:v>
                  </c:pt>
                  <c:pt idx="2">
                    <c:v>0.61915959439435464</c:v>
                  </c:pt>
                  <c:pt idx="3">
                    <c:v>3.617048165536509</c:v>
                  </c:pt>
                  <c:pt idx="4">
                    <c:v>0.60464602434752768</c:v>
                  </c:pt>
                  <c:pt idx="5">
                    <c:v>1.4695364780980156</c:v>
                  </c:pt>
                  <c:pt idx="6">
                    <c:v>2.504865627695875</c:v>
                  </c:pt>
                </c:numCache>
              </c:numRef>
            </c:plus>
            <c:minus>
              <c:numRef>
                <c:f>'D:\pH.D\[กว่าจะเป็น phD.xlsx]FRAP Invitro'!$N$41:$N$47</c:f>
                <c:numCache>
                  <c:formatCode>General</c:formatCode>
                  <c:ptCount val="7"/>
                  <c:pt idx="0">
                    <c:v>1.2719288144530927</c:v>
                  </c:pt>
                  <c:pt idx="1">
                    <c:v>0.19991004048172556</c:v>
                  </c:pt>
                  <c:pt idx="2">
                    <c:v>0.61915959439435464</c:v>
                  </c:pt>
                  <c:pt idx="3">
                    <c:v>3.617048165536509</c:v>
                  </c:pt>
                  <c:pt idx="4">
                    <c:v>0.60464602434752768</c:v>
                  </c:pt>
                  <c:pt idx="5">
                    <c:v>1.4695364780980156</c:v>
                  </c:pt>
                  <c:pt idx="6">
                    <c:v>2.5048656276958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FRAP Invitro'!$A$41:$A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FRAP Invitro'!$C$41:$C$47</c:f>
              <c:numCache>
                <c:formatCode>General</c:formatCode>
                <c:ptCount val="7"/>
                <c:pt idx="0">
                  <c:v>82.718332306017828</c:v>
                </c:pt>
                <c:pt idx="1">
                  <c:v>182.65114032018926</c:v>
                </c:pt>
                <c:pt idx="2">
                  <c:v>236.11597003570623</c:v>
                </c:pt>
                <c:pt idx="3">
                  <c:v>158.88405772957728</c:v>
                </c:pt>
                <c:pt idx="4">
                  <c:v>157.08936534115199</c:v>
                </c:pt>
                <c:pt idx="5">
                  <c:v>152.08936534115</c:v>
                </c:pt>
                <c:pt idx="6">
                  <c:v>147.089365341152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849D-4E06-AE06-F1FF729B198F}"/>
            </c:ext>
          </c:extLst>
        </c:ser>
        <c:ser>
          <c:idx val="2"/>
          <c:order val="2"/>
          <c:tx>
            <c:strRef>
              <c:f>'D:\pH.D\[กว่าจะเป็น phD.xlsx]FRAP Invitro'!$D$40</c:f>
              <c:strCache>
                <c:ptCount val="1"/>
                <c:pt idx="0">
                  <c:v>Flavourzyme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FRAP Invitro'!$O$41:$O$47</c:f>
                <c:numCache>
                  <c:formatCode>General</c:formatCode>
                  <c:ptCount val="7"/>
                  <c:pt idx="0">
                    <c:v>1.2719288144530791</c:v>
                  </c:pt>
                  <c:pt idx="1">
                    <c:v>0.16769863417617784</c:v>
                  </c:pt>
                  <c:pt idx="2">
                    <c:v>0.37891220304709938</c:v>
                  </c:pt>
                  <c:pt idx="3">
                    <c:v>0.78563487247747676</c:v>
                  </c:pt>
                  <c:pt idx="4">
                    <c:v>0.40715684119531398</c:v>
                  </c:pt>
                  <c:pt idx="5">
                    <c:v>0.46645676112412104</c:v>
                  </c:pt>
                  <c:pt idx="6">
                    <c:v>0.90961712693479513</c:v>
                  </c:pt>
                </c:numCache>
              </c:numRef>
            </c:plus>
            <c:minus>
              <c:numRef>
                <c:f>'D:\pH.D\[กว่าจะเป็น phD.xlsx]FRAP Invitro'!$O$41:$O$47</c:f>
                <c:numCache>
                  <c:formatCode>General</c:formatCode>
                  <c:ptCount val="7"/>
                  <c:pt idx="0">
                    <c:v>1.2719288144530791</c:v>
                  </c:pt>
                  <c:pt idx="1">
                    <c:v>0.16769863417617784</c:v>
                  </c:pt>
                  <c:pt idx="2">
                    <c:v>0.37891220304709938</c:v>
                  </c:pt>
                  <c:pt idx="3">
                    <c:v>0.78563487247747676</c:v>
                  </c:pt>
                  <c:pt idx="4">
                    <c:v>0.40715684119531398</c:v>
                  </c:pt>
                  <c:pt idx="5">
                    <c:v>0.46645676112412104</c:v>
                  </c:pt>
                  <c:pt idx="6">
                    <c:v>0.90961712693479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FRAP Invitro'!$A$41:$A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FRAP Invitro'!$D$41:$D$47</c:f>
              <c:numCache>
                <c:formatCode>General</c:formatCode>
                <c:ptCount val="7"/>
                <c:pt idx="0">
                  <c:v>76.05466428995841</c:v>
                </c:pt>
                <c:pt idx="1">
                  <c:v>189.53693060345063</c:v>
                </c:pt>
                <c:pt idx="2">
                  <c:v>195.06777505677999</c:v>
                </c:pt>
                <c:pt idx="3">
                  <c:v>181.71822679794096</c:v>
                </c:pt>
                <c:pt idx="4">
                  <c:v>181.22955781009659</c:v>
                </c:pt>
                <c:pt idx="5">
                  <c:v>167.52461392373431</c:v>
                </c:pt>
                <c:pt idx="6">
                  <c:v>140.488735624524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849D-4E06-AE06-F1FF729B198F}"/>
            </c:ext>
          </c:extLst>
        </c:ser>
        <c:ser>
          <c:idx val="3"/>
          <c:order val="3"/>
          <c:tx>
            <c:strRef>
              <c:f>'D:\pH.D\[กว่าจะเป็น phD.xlsx]FRAP Invitro'!$E$40</c:f>
              <c:strCache>
                <c:ptCount val="1"/>
                <c:pt idx="0">
                  <c:v>Papain made PP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pH.D\[กว่าจะเป็น phD.xlsx]FRAP Invitro'!$P$41:$P$47</c:f>
                <c:numCache>
                  <c:formatCode>General</c:formatCode>
                  <c:ptCount val="7"/>
                  <c:pt idx="0">
                    <c:v>0.50014516797208797</c:v>
                  </c:pt>
                  <c:pt idx="1">
                    <c:v>0.83318059466620942</c:v>
                  </c:pt>
                  <c:pt idx="2">
                    <c:v>0.50309590252858627</c:v>
                  </c:pt>
                  <c:pt idx="3">
                    <c:v>0.60464602434756576</c:v>
                  </c:pt>
                  <c:pt idx="4">
                    <c:v>0.2402619671457174</c:v>
                  </c:pt>
                  <c:pt idx="5">
                    <c:v>0.65629518728546987</c:v>
                  </c:pt>
                  <c:pt idx="6">
                    <c:v>0.76849168505313203</c:v>
                  </c:pt>
                </c:numCache>
              </c:numRef>
            </c:plus>
            <c:minus>
              <c:numRef>
                <c:f>'D:\pH.D\[กว่าจะเป็น phD.xlsx]FRAP Invitro'!$P$41:$P$47</c:f>
                <c:numCache>
                  <c:formatCode>General</c:formatCode>
                  <c:ptCount val="7"/>
                  <c:pt idx="0">
                    <c:v>0.50014516797208797</c:v>
                  </c:pt>
                  <c:pt idx="1">
                    <c:v>0.83318059466620942</c:v>
                  </c:pt>
                  <c:pt idx="2">
                    <c:v>0.50309590252858627</c:v>
                  </c:pt>
                  <c:pt idx="3">
                    <c:v>0.60464602434756576</c:v>
                  </c:pt>
                  <c:pt idx="4">
                    <c:v>0.2402619671457174</c:v>
                  </c:pt>
                  <c:pt idx="5">
                    <c:v>0.65629518728546987</c:v>
                  </c:pt>
                  <c:pt idx="6">
                    <c:v>0.768491685053132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:\pH.D\[กว่าจะเป็น phD.xlsx]FRAP Invitro'!$A$41:$A$47</c:f>
              <c:numCache>
                <c:formatCode>General</c:formatCode>
                <c:ptCount val="7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80</c:v>
                </c:pt>
                <c:pt idx="6">
                  <c:v>360</c:v>
                </c:pt>
              </c:numCache>
            </c:numRef>
          </c:xVal>
          <c:yVal>
            <c:numRef>
              <c:f>'D:\pH.D\[กว่าจะเป็น phD.xlsx]FRAP Invitro'!$E$41:$E$47</c:f>
              <c:numCache>
                <c:formatCode>General</c:formatCode>
                <c:ptCount val="7"/>
                <c:pt idx="0">
                  <c:v>26.54361093063677</c:v>
                </c:pt>
                <c:pt idx="1">
                  <c:v>195.53423181790413</c:v>
                </c:pt>
                <c:pt idx="2">
                  <c:v>164.59259999666816</c:v>
                </c:pt>
                <c:pt idx="3">
                  <c:v>155.84098266891007</c:v>
                </c:pt>
                <c:pt idx="4">
                  <c:v>153.99736785113365</c:v>
                </c:pt>
                <c:pt idx="5">
                  <c:v>139.67048161660588</c:v>
                </c:pt>
                <c:pt idx="6">
                  <c:v>134.0730004831159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849D-4E06-AE06-F1FF729B19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7587872"/>
        <c:axId val="417588264"/>
      </c:scatterChart>
      <c:valAx>
        <c:axId val="417587872"/>
        <c:scaling>
          <c:orientation val="minMax"/>
          <c:max val="36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gestion time 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8264"/>
        <c:crosses val="autoZero"/>
        <c:crossBetween val="midCat"/>
        <c:majorUnit val="30"/>
      </c:valAx>
      <c:valAx>
        <c:axId val="417588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b="0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ucing power  (mmol TE/g)</a:t>
                </a:r>
                <a:endParaRPr lang="en-GB" sz="1050" b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0149915980038272E-2"/>
              <c:y val="0.130187305685165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75878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9265759717058322E-2"/>
          <c:y val="0.88774500080017849"/>
          <c:w val="0.94295603086806956"/>
          <c:h val="0.110468732181651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105</cdr:x>
      <cdr:y>0.0988</cdr:y>
    </cdr:from>
    <cdr:to>
      <cdr:x>0.26432</cdr:x>
      <cdr:y>0.09946</cdr:y>
    </cdr:to>
    <cdr:cxnSp macro="">
      <cdr:nvCxnSpPr>
        <cdr:cNvPr id="3" name="Straight Arrow Connector 2">
          <a:extLst xmlns:a="http://schemas.openxmlformats.org/drawingml/2006/main">
            <a:ext uri="{FF2B5EF4-FFF2-40B4-BE49-F238E27FC236}">
              <a16:creationId xmlns:a16="http://schemas.microsoft.com/office/drawing/2014/main" xmlns="" id="{A6196C21-5143-4C2C-A0D7-98D70DA139C0}"/>
            </a:ext>
          </a:extLst>
        </cdr:cNvPr>
        <cdr:cNvCxnSpPr/>
      </cdr:nvCxnSpPr>
      <cdr:spPr>
        <a:xfrm xmlns:a="http://schemas.openxmlformats.org/drawingml/2006/main" flipV="1">
          <a:off x="585495" y="315292"/>
          <a:ext cx="595414" cy="2106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354</cdr:x>
      <cdr:y>0.09925</cdr:y>
    </cdr:from>
    <cdr:to>
      <cdr:x>0.95833</cdr:x>
      <cdr:y>0.10204</cdr:y>
    </cdr:to>
    <cdr:cxnSp macro="">
      <cdr:nvCxnSpPr>
        <cdr:cNvPr id="5" name="Straight Arrow Connector 4">
          <a:extLst xmlns:a="http://schemas.openxmlformats.org/drawingml/2006/main">
            <a:ext uri="{FF2B5EF4-FFF2-40B4-BE49-F238E27FC236}">
              <a16:creationId xmlns:a16="http://schemas.microsoft.com/office/drawing/2014/main" xmlns="" id="{8896B812-99F8-4ABC-9F48-85344AF18F01}"/>
            </a:ext>
          </a:extLst>
        </cdr:cNvPr>
        <cdr:cNvCxnSpPr/>
      </cdr:nvCxnSpPr>
      <cdr:spPr>
        <a:xfrm xmlns:a="http://schemas.openxmlformats.org/drawingml/2006/main">
          <a:off x="1245068" y="339698"/>
          <a:ext cx="3282482" cy="9552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579</cdr:x>
      <cdr:y>0.02355</cdr:y>
    </cdr:from>
    <cdr:to>
      <cdr:x>0.30912</cdr:x>
      <cdr:y>0.08581</cdr:y>
    </cdr:to>
    <cdr:sp macro="" textlink="">
      <cdr:nvSpPr>
        <cdr:cNvPr id="11" name="Rectangle 10">
          <a:extLst xmlns:a="http://schemas.openxmlformats.org/drawingml/2006/main">
            <a:ext uri="{FF2B5EF4-FFF2-40B4-BE49-F238E27FC236}">
              <a16:creationId xmlns:a16="http://schemas.microsoft.com/office/drawing/2014/main" xmlns="" id="{1079A9D2-DBD2-4BBD-955B-75B5616FEBAC}"/>
            </a:ext>
          </a:extLst>
        </cdr:cNvPr>
        <cdr:cNvSpPr/>
      </cdr:nvSpPr>
      <cdr:spPr>
        <a:xfrm xmlns:a="http://schemas.openxmlformats.org/drawingml/2006/main">
          <a:off x="637381" y="82549"/>
          <a:ext cx="813594" cy="21828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r>
            <a:rPr lang="en-US" b="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astric</a:t>
          </a:r>
          <a:endParaRPr lang="en-US" b="0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659</cdr:x>
      <cdr:y>0.02298</cdr:y>
    </cdr:from>
    <cdr:to>
      <cdr:x>0.76359</cdr:x>
      <cdr:y>0.08298</cdr:y>
    </cdr:to>
    <cdr:sp macro="" textlink="">
      <cdr:nvSpPr>
        <cdr:cNvPr id="12" name="Rectangle 11">
          <a:extLst xmlns:a="http://schemas.openxmlformats.org/drawingml/2006/main">
            <a:ext uri="{FF2B5EF4-FFF2-40B4-BE49-F238E27FC236}">
              <a16:creationId xmlns:a16="http://schemas.microsoft.com/office/drawing/2014/main" xmlns="" id="{9EB5853C-D6EA-4888-BDAC-7BCBA69CC8EC}"/>
            </a:ext>
          </a:extLst>
        </cdr:cNvPr>
        <cdr:cNvSpPr/>
      </cdr:nvSpPr>
      <cdr:spPr>
        <a:xfrm xmlns:a="http://schemas.openxmlformats.org/drawingml/2006/main">
          <a:off x="2471738" y="80566"/>
          <a:ext cx="1112440" cy="21034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Duodenal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219</cdr:x>
      <cdr:y>0.07852</cdr:y>
    </cdr:from>
    <cdr:to>
      <cdr:x>0.27842</cdr:x>
      <cdr:y>0.07852</cdr:y>
    </cdr:to>
    <cdr:cxnSp macro="">
      <cdr:nvCxnSpPr>
        <cdr:cNvPr id="2" name="Straight Arrow Connector 1">
          <a:extLst xmlns:a="http://schemas.openxmlformats.org/drawingml/2006/main">
            <a:ext uri="{FF2B5EF4-FFF2-40B4-BE49-F238E27FC236}">
              <a16:creationId xmlns:a16="http://schemas.microsoft.com/office/drawing/2014/main" xmlns="" id="{1A7FBFBC-F97F-4C32-A571-1BA2C97CBC1F}"/>
            </a:ext>
          </a:extLst>
        </cdr:cNvPr>
        <cdr:cNvCxnSpPr/>
      </cdr:nvCxnSpPr>
      <cdr:spPr>
        <a:xfrm xmlns:a="http://schemas.openxmlformats.org/drawingml/2006/main">
          <a:off x="560029" y="233285"/>
          <a:ext cx="719064" cy="0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7482</cdr:x>
      <cdr:y>0.07852</cdr:y>
    </cdr:from>
    <cdr:to>
      <cdr:x>0.97319</cdr:x>
      <cdr:y>0.07852</cdr:y>
    </cdr:to>
    <cdr:cxnSp macro="">
      <cdr:nvCxnSpPr>
        <cdr:cNvPr id="3" name="Straight Arrow Connector 2">
          <a:extLst xmlns:a="http://schemas.openxmlformats.org/drawingml/2006/main">
            <a:ext uri="{FF2B5EF4-FFF2-40B4-BE49-F238E27FC236}">
              <a16:creationId xmlns:a16="http://schemas.microsoft.com/office/drawing/2014/main" xmlns="" id="{D3E0D590-293C-4A69-8B11-625B9BC43CDB}"/>
            </a:ext>
          </a:extLst>
        </cdr:cNvPr>
        <cdr:cNvCxnSpPr/>
      </cdr:nvCxnSpPr>
      <cdr:spPr>
        <a:xfrm xmlns:a="http://schemas.openxmlformats.org/drawingml/2006/main">
          <a:off x="1262556" y="233285"/>
          <a:ext cx="3208420" cy="0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445</cdr:x>
      <cdr:y>0</cdr:y>
    </cdr:from>
    <cdr:to>
      <cdr:x>0.32532</cdr:x>
      <cdr:y>0.06605</cdr:y>
    </cdr:to>
    <cdr:sp macro="" textlink="">
      <cdr:nvSpPr>
        <cdr:cNvPr id="4" name="Rectangle 3">
          <a:extLst xmlns:a="http://schemas.openxmlformats.org/drawingml/2006/main">
            <a:ext uri="{FF2B5EF4-FFF2-40B4-BE49-F238E27FC236}">
              <a16:creationId xmlns:a16="http://schemas.microsoft.com/office/drawing/2014/main" xmlns="" id="{BF5B820A-5A65-450F-91BF-3A365A655509}"/>
            </a:ext>
          </a:extLst>
        </cdr:cNvPr>
        <cdr:cNvSpPr/>
      </cdr:nvSpPr>
      <cdr:spPr>
        <a:xfrm xmlns:a="http://schemas.openxmlformats.org/drawingml/2006/main">
          <a:off x="617690" y="-2957666"/>
          <a:ext cx="876882" cy="1962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astric</a:t>
          </a:r>
          <a:endParaRPr lang="en-US" b="0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838</cdr:x>
      <cdr:y>7.405E-5</cdr:y>
    </cdr:from>
    <cdr:to>
      <cdr:x>0.78937</cdr:x>
      <cdr:y>0.06373</cdr:y>
    </cdr:to>
    <cdr:sp macro="" textlink="">
      <cdr:nvSpPr>
        <cdr:cNvPr id="5" name="Rectangle 4">
          <a:extLst xmlns:a="http://schemas.openxmlformats.org/drawingml/2006/main">
            <a:ext uri="{FF2B5EF4-FFF2-40B4-BE49-F238E27FC236}">
              <a16:creationId xmlns:a16="http://schemas.microsoft.com/office/drawing/2014/main" xmlns="" id="{36A4633E-B0A6-4FE7-889E-A65DF9E5C65F}"/>
            </a:ext>
          </a:extLst>
        </cdr:cNvPr>
        <cdr:cNvSpPr/>
      </cdr:nvSpPr>
      <cdr:spPr>
        <a:xfrm xmlns:a="http://schemas.openxmlformats.org/drawingml/2006/main">
          <a:off x="2427459" y="220"/>
          <a:ext cx="1199022" cy="1891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Duodenal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2748</cdr:x>
      <cdr:y>0.10952</cdr:y>
    </cdr:from>
    <cdr:to>
      <cdr:x>0.26431</cdr:x>
      <cdr:y>0.11024</cdr:y>
    </cdr:to>
    <cdr:cxnSp macro="">
      <cdr:nvCxnSpPr>
        <cdr:cNvPr id="2" name="Straight Arrow Connector 1">
          <a:extLst xmlns:a="http://schemas.openxmlformats.org/drawingml/2006/main">
            <a:ext uri="{FF2B5EF4-FFF2-40B4-BE49-F238E27FC236}">
              <a16:creationId xmlns:a16="http://schemas.microsoft.com/office/drawing/2014/main" xmlns="" id="{B6337029-2A74-46D8-91F4-E45CAC69FBA7}"/>
            </a:ext>
          </a:extLst>
        </cdr:cNvPr>
        <cdr:cNvCxnSpPr/>
      </cdr:nvCxnSpPr>
      <cdr:spPr>
        <a:xfrm xmlns:a="http://schemas.openxmlformats.org/drawingml/2006/main" flipV="1">
          <a:off x="627764" y="354686"/>
          <a:ext cx="673793" cy="2323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351</cdr:x>
      <cdr:y>0.10294</cdr:y>
    </cdr:from>
    <cdr:to>
      <cdr:x>0.97099</cdr:x>
      <cdr:y>0.11001</cdr:y>
    </cdr:to>
    <cdr:cxnSp macro="">
      <cdr:nvCxnSpPr>
        <cdr:cNvPr id="3" name="Straight Arrow Connector 2">
          <a:extLst xmlns:a="http://schemas.openxmlformats.org/drawingml/2006/main">
            <a:ext uri="{FF2B5EF4-FFF2-40B4-BE49-F238E27FC236}">
              <a16:creationId xmlns:a16="http://schemas.microsoft.com/office/drawing/2014/main" xmlns="" id="{72123418-031C-490C-826F-B9701713BEA9}"/>
            </a:ext>
          </a:extLst>
        </cdr:cNvPr>
        <cdr:cNvCxnSpPr/>
      </cdr:nvCxnSpPr>
      <cdr:spPr>
        <a:xfrm xmlns:a="http://schemas.openxmlformats.org/drawingml/2006/main" flipV="1">
          <a:off x="1297611" y="333376"/>
          <a:ext cx="3483939" cy="22884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235</cdr:x>
      <cdr:y>0.02806</cdr:y>
    </cdr:from>
    <cdr:to>
      <cdr:x>0.3103</cdr:x>
      <cdr:y>0.09547</cdr:y>
    </cdr:to>
    <cdr:sp macro="" textlink="">
      <cdr:nvSpPr>
        <cdr:cNvPr id="4" name="Rectangle 3">
          <a:extLst xmlns:a="http://schemas.openxmlformats.org/drawingml/2006/main">
            <a:ext uri="{FF2B5EF4-FFF2-40B4-BE49-F238E27FC236}">
              <a16:creationId xmlns:a16="http://schemas.microsoft.com/office/drawing/2014/main" xmlns="" id="{72FDBE29-C464-4C15-846B-094B726C3143}"/>
            </a:ext>
          </a:extLst>
        </cdr:cNvPr>
        <cdr:cNvSpPr/>
      </cdr:nvSpPr>
      <cdr:spPr>
        <a:xfrm xmlns:a="http://schemas.openxmlformats.org/drawingml/2006/main">
          <a:off x="651741" y="90883"/>
          <a:ext cx="876308" cy="21828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astric</a:t>
          </a:r>
          <a:endParaRPr lang="en-US" b="0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3356</cdr:x>
      <cdr:y>0.02745</cdr:y>
    </cdr:from>
    <cdr:to>
      <cdr:x>0.77688</cdr:x>
      <cdr:y>0.0924</cdr:y>
    </cdr:to>
    <cdr:sp macro="" textlink="">
      <cdr:nvSpPr>
        <cdr:cNvPr id="5" name="Rectangle 4">
          <a:extLst xmlns:a="http://schemas.openxmlformats.org/drawingml/2006/main">
            <a:ext uri="{FF2B5EF4-FFF2-40B4-BE49-F238E27FC236}">
              <a16:creationId xmlns:a16="http://schemas.microsoft.com/office/drawing/2014/main" xmlns="" id="{F619F071-D2B7-40FD-B479-8B1AC23549B4}"/>
            </a:ext>
          </a:extLst>
        </cdr:cNvPr>
        <cdr:cNvSpPr/>
      </cdr:nvSpPr>
      <cdr:spPr>
        <a:xfrm xmlns:a="http://schemas.openxmlformats.org/drawingml/2006/main">
          <a:off x="2627496" y="88900"/>
          <a:ext cx="1198191" cy="21034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Duodenal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8A00E7-4D81-4B24-84C3-DCED635936A3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h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1CA3-B140-4DE2-AD28-FE729612142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79505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538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19978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09884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5573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8173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2754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4717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20632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4816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11300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0521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6193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9D3073AD-B1E3-4D89-82B8-193735C77C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3447011"/>
              </p:ext>
            </p:extLst>
          </p:nvPr>
        </p:nvGraphicFramePr>
        <p:xfrm>
          <a:off x="1323473" y="189567"/>
          <a:ext cx="4467726" cy="31912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53E4162A-378C-42FD-B6A9-7C991A29B2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214282"/>
              </p:ext>
            </p:extLst>
          </p:nvPr>
        </p:nvGraphicFramePr>
        <p:xfrm>
          <a:off x="1313376" y="2957666"/>
          <a:ext cx="4594130" cy="29709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C3899EE8-0ACF-4487-8741-039F5E6C35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8213665"/>
              </p:ext>
            </p:extLst>
          </p:nvPr>
        </p:nvGraphicFramePr>
        <p:xfrm>
          <a:off x="1253447" y="5614322"/>
          <a:ext cx="4690154" cy="3129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784352" y="416051"/>
            <a:ext cx="659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784352" y="3052452"/>
            <a:ext cx="659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784352" y="5827352"/>
            <a:ext cx="659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9338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05</TotalTime>
  <Words>54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ordia New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DELL</cp:lastModifiedBy>
  <cp:revision>424</cp:revision>
  <dcterms:created xsi:type="dcterms:W3CDTF">2019-11-18T02:47:29Z</dcterms:created>
  <dcterms:modified xsi:type="dcterms:W3CDTF">2021-05-29T08:50:35Z</dcterms:modified>
</cp:coreProperties>
</file>